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2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8" autoAdjust="0"/>
    <p:restoredTop sz="94660"/>
  </p:normalViewPr>
  <p:slideViewPr>
    <p:cSldViewPr snapToGrid="0">
      <p:cViewPr varScale="1">
        <p:scale>
          <a:sx n="98" d="100"/>
          <a:sy n="98" d="100"/>
        </p:scale>
        <p:origin x="52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wangyarong\Desktop\&#32769;&#33635;\03%20MYBTT\08%20&#26792;&#30456;&#20284;&#22522;&#22240;&#23547;&#25214;\&#26792;&#36716;&#24405;&#32452;&#27979;&#23450;\&#36716;&#24405;&#32452;&#27979;&#24207;&#34920;&#36798;&#37327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wangyarong\Desktop\&#32769;&#33635;\03%20MYBTT\08%20&#26792;&#30456;&#20284;&#22522;&#22240;&#23547;&#25214;\&#26792;&#36716;&#24405;&#32452;&#27979;&#23450;\&#36716;&#24405;&#32452;&#27979;&#24207;&#34920;&#36798;&#37327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G$19</c:f>
              <c:strCache>
                <c:ptCount val="1"/>
                <c:pt idx="0">
                  <c:v>30 DAFB</c:v>
                </c:pt>
              </c:strCache>
            </c:strRef>
          </c:tx>
          <c:spPr>
            <a:solidFill>
              <a:srgbClr val="90639F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G$25:$G$2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6.9278773962765675E-2</c:v>
                  </c:pt>
                  <c:pt idx="2">
                    <c:v>0</c:v>
                  </c:pt>
                  <c:pt idx="3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F$20:$F$23</c:f>
              <c:strCache>
                <c:ptCount val="4"/>
                <c:pt idx="0">
                  <c:v>Betulifolia</c:v>
                </c:pt>
                <c:pt idx="1">
                  <c:v>Calleryana</c:v>
                </c:pt>
                <c:pt idx="2">
                  <c:v>Dangshansuli</c:v>
                </c:pt>
                <c:pt idx="3">
                  <c:v>Hongxiangsu</c:v>
                </c:pt>
              </c:strCache>
            </c:strRef>
          </c:cat>
          <c:val>
            <c:numRef>
              <c:f>Sheet2!$G$20:$G$23</c:f>
              <c:numCache>
                <c:formatCode>General</c:formatCode>
                <c:ptCount val="4"/>
                <c:pt idx="0">
                  <c:v>0</c:v>
                </c:pt>
                <c:pt idx="1">
                  <c:v>3.9998118796530001E-2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DEB-463D-B2DE-10C891B42715}"/>
            </c:ext>
          </c:extLst>
        </c:ser>
        <c:ser>
          <c:idx val="1"/>
          <c:order val="1"/>
          <c:tx>
            <c:strRef>
              <c:f>Sheet2!$H$19</c:f>
              <c:strCache>
                <c:ptCount val="1"/>
                <c:pt idx="0">
                  <c:v>120 DAFB</c:v>
                </c:pt>
              </c:strCache>
            </c:strRef>
          </c:tx>
          <c:spPr>
            <a:solidFill>
              <a:srgbClr val="9AB84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H$25:$H$2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F$20:$F$23</c:f>
              <c:strCache>
                <c:ptCount val="4"/>
                <c:pt idx="0">
                  <c:v>Betulifolia</c:v>
                </c:pt>
                <c:pt idx="1">
                  <c:v>Calleryana</c:v>
                </c:pt>
                <c:pt idx="2">
                  <c:v>Dangshansuli</c:v>
                </c:pt>
                <c:pt idx="3">
                  <c:v>Hongxiangsu</c:v>
                </c:pt>
              </c:strCache>
            </c:strRef>
          </c:cat>
          <c:val>
            <c:numRef>
              <c:f>Sheet2!$H$20:$H$23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DEB-463D-B2DE-10C891B427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35765904"/>
        <c:axId val="932350272"/>
      </c:barChart>
      <c:catAx>
        <c:axId val="9357659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932350272"/>
        <c:crosses val="autoZero"/>
        <c:auto val="1"/>
        <c:lblAlgn val="ctr"/>
        <c:lblOffset val="100"/>
        <c:noMultiLvlLbl val="0"/>
      </c:catAx>
      <c:valAx>
        <c:axId val="9323502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9357659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96465817058934"/>
          <c:y val="0.12446610089968127"/>
          <c:w val="0.40325902312171125"/>
          <c:h val="0.1524571220110348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>
            <a:defRPr lang="en-US" altLang="zh-CN" sz="8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7761592300962384E-2"/>
          <c:y val="0.18039370078740158"/>
          <c:w val="0.88890507436570432"/>
          <c:h val="0.6627770487022455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N$19</c:f>
              <c:strCache>
                <c:ptCount val="1"/>
                <c:pt idx="0">
                  <c:v>30 DAFB</c:v>
                </c:pt>
              </c:strCache>
            </c:strRef>
          </c:tx>
          <c:spPr>
            <a:solidFill>
              <a:srgbClr val="90639F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N$25:$N$28</c:f>
                <c:numCache>
                  <c:formatCode>General</c:formatCode>
                  <c:ptCount val="4"/>
                  <c:pt idx="0">
                    <c:v>4.8020657171983318E-2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M$20:$M$23</c:f>
              <c:strCache>
                <c:ptCount val="4"/>
                <c:pt idx="0">
                  <c:v>Betulifolia</c:v>
                </c:pt>
                <c:pt idx="1">
                  <c:v>Calleryana</c:v>
                </c:pt>
                <c:pt idx="2">
                  <c:v>Dangshansuli</c:v>
                </c:pt>
                <c:pt idx="3">
                  <c:v>Hongxiangsu</c:v>
                </c:pt>
              </c:strCache>
            </c:strRef>
          </c:cat>
          <c:val>
            <c:numRef>
              <c:f>Sheet2!$N$20:$N$23</c:f>
              <c:numCache>
                <c:formatCode>General</c:formatCode>
                <c:ptCount val="4"/>
                <c:pt idx="0">
                  <c:v>2.7724739344907299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3CC-4F1E-B876-F268FA17C6B7}"/>
            </c:ext>
          </c:extLst>
        </c:ser>
        <c:ser>
          <c:idx val="1"/>
          <c:order val="1"/>
          <c:tx>
            <c:strRef>
              <c:f>Sheet2!$O$19</c:f>
              <c:strCache>
                <c:ptCount val="1"/>
                <c:pt idx="0">
                  <c:v>120 DAFB</c:v>
                </c:pt>
              </c:strCache>
            </c:strRef>
          </c:tx>
          <c:spPr>
            <a:solidFill>
              <a:srgbClr val="9AB84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O$25:$O$28</c:f>
                <c:numCache>
                  <c:formatCode>General</c:formatCode>
                  <c:ptCount val="4"/>
                  <c:pt idx="0">
                    <c:v>3.9270801320048385E-2</c:v>
                  </c:pt>
                  <c:pt idx="1">
                    <c:v>3.9270801320048385E-2</c:v>
                  </c:pt>
                  <c:pt idx="2">
                    <c:v>0</c:v>
                  </c:pt>
                  <c:pt idx="3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M$20:$M$23</c:f>
              <c:strCache>
                <c:ptCount val="4"/>
                <c:pt idx="0">
                  <c:v>Betulifolia</c:v>
                </c:pt>
                <c:pt idx="1">
                  <c:v>Calleryana</c:v>
                </c:pt>
                <c:pt idx="2">
                  <c:v>Dangshansuli</c:v>
                </c:pt>
                <c:pt idx="3">
                  <c:v>Hongxiangsu</c:v>
                </c:pt>
              </c:strCache>
            </c:strRef>
          </c:cat>
          <c:val>
            <c:numRef>
              <c:f>Sheet2!$O$20:$O$23</c:f>
              <c:numCache>
                <c:formatCode>General</c:formatCode>
                <c:ptCount val="4"/>
                <c:pt idx="0">
                  <c:v>4.159420060661647E-2</c:v>
                </c:pt>
                <c:pt idx="1">
                  <c:v>4.159420060661647E-2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3CC-4F1E-B876-F268FA17C6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81648720"/>
        <c:axId val="981649376"/>
      </c:barChart>
      <c:catAx>
        <c:axId val="9816487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981649376"/>
        <c:crosses val="autoZero"/>
        <c:auto val="1"/>
        <c:lblAlgn val="ctr"/>
        <c:lblOffset val="100"/>
        <c:noMultiLvlLbl val="0"/>
      </c:catAx>
      <c:valAx>
        <c:axId val="9816493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981648720"/>
        <c:crosses val="autoZero"/>
        <c:crossBetween val="between"/>
        <c:majorUnit val="2.0000000000000004E-2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4845677315973507"/>
          <c:y val="0.19946529529793378"/>
          <c:w val="0.44434711115618913"/>
          <c:h val="0.2740850042080197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>
            <a:defRPr lang="en-US" altLang="zh-CN" sz="8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35B1ED-F86F-4A3D-91B0-93F525F5E2CF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29CFD8-7C1C-4BC9-A9F7-2D549B3ACB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13990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81FCCB-F7A0-47AD-AC20-7C96967510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32770C7-1181-4EBE-AB4F-34A034A60E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49BC00-2C8E-4F9E-8DFC-AD3EFA0979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265B3CB-4DFD-4380-9E33-2D19558021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AB632F5-4004-43BE-A894-48AE73934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49078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9100160-3FDC-44D0-9F62-277CA77C46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DD6F321-DC31-49E0-9A4A-9A631B70C0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E83C318-0B67-410A-8C04-26BF21A40E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5BFE5AC-9838-4537-8264-C3CCD4619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525C987-EFEC-46DE-BC11-02CA11634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93364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7C7DCFA-689C-40BD-9587-38DD677E66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0EF6F39-C995-4EF4-AEB1-21FD2E6E8C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0547461-557A-4E09-856C-D537B58D8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C0B3021-015A-4A32-9262-E7D2F6440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A3F7901-7663-40B5-A438-AA35C1CB74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7192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FABF3C-2C26-479B-B49D-1563166566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214D1EE-F4EB-45AF-B160-F4E14B9AF5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C2F6C5-6B95-4C43-BD28-3948CB912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6072172-9FE6-4C79-BA7E-D449435AF9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F1655CD-FB00-4867-8CC9-38EE57D6A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2436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D904A8-7140-4E15-ABC8-BCACA51AEE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9FE273F-F3BC-4EDA-95A7-287DEAD5A0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34E2D2-2981-4C7A-BBD6-21BAD9FFD1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F92DAE7-75F6-46BC-9353-6AD3807A9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4969101-EBD7-419D-9D1A-0761C02F91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3404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E40A1C-33C3-420A-BE99-561D7CB368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3428511-47B8-4435-BDBD-19796BCFC6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BB3B03E-269F-41C4-B194-26BC20D52A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AFAE765-492A-4702-9F98-B5A0234652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76668DD-9BE5-4181-8236-17007EF08E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F212379-62ED-4F44-B90D-4A98EBE044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2815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B82C16-2549-445F-BD14-00AC56AE5D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A59E935-FF0E-45DC-A42F-A0C23CE059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445E1EA-7914-47D5-AEC1-EDABAE649E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8731DD7-68F7-4EA0-9D34-8247DE5E87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B66F667-0631-4AF0-AA34-78FBE3A81E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E6FFC3E-8156-49E8-BC5F-484077B5E5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8AD6E16-5809-4B02-879A-F014EE1E7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E640E36-B09A-4618-A27B-FF48F82BB0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4892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033ABD-8856-47F0-AD8D-81B476E95F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B638DD1-D36C-43EC-87E7-212A2F5605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2AC69A6-522A-4D94-9C26-0FA9826639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464667C-7B27-44B4-A899-E9754EABB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5015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2F695B8-0299-4A81-A058-11D1C123E4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FF9A398-FA1B-42B3-ABBE-CF2A33DA14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F461A4F-9387-473F-80EC-BB947A23F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3797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FA41EB-ADF1-4171-BA2E-F899D7E1D4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A198B67-43A3-4908-9D87-7B8ED5B3E3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65D3868-63DA-445C-959E-6A81AE1862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7628954-8310-429C-B879-0C39566619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5A5AB87-4358-4C34-A45D-EF19D0A0A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CAEFFEE-FFCE-4767-BC57-900D0AEF22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9611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1C9578-790E-4EFC-AD7D-5D36B63495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4CBD583-BC12-4947-B31C-1BE07F03A4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FCEEDC9-0E30-4C91-BAC4-3F5E0985E1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0DD3960-C2F5-4B95-B4A7-AE98605461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86B8756-5B6D-4A90-A48F-2FCFD92B9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68163B7-88DA-4D9C-B1AB-1B7E8AB225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5464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01A57E7-A18D-43AF-87BE-53F6DC0D9B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202DFA5-BB78-4CA9-9DFC-E9447FA528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CEB0252-DAC6-4D3D-99B9-395345D5B1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DE0D05-08B2-46BF-91F3-5A6DA98064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19C1876-B017-4C34-BD68-5098EEA4571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1411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image" Target="../media/image4.sv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openxmlformats.org/officeDocument/2006/relationships/image" Target="../media/image2.sv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>
            <a:extLst>
              <a:ext uri="{FF2B5EF4-FFF2-40B4-BE49-F238E27FC236}">
                <a16:creationId xmlns:a16="http://schemas.microsoft.com/office/drawing/2014/main" id="{7EC5B8F2-F8FC-4E93-9360-6D37B5DF4603}"/>
              </a:ext>
            </a:extLst>
          </p:cNvPr>
          <p:cNvGraphicFramePr>
            <a:graphicFrameLocks/>
          </p:cNvGraphicFramePr>
          <p:nvPr/>
        </p:nvGraphicFramePr>
        <p:xfrm>
          <a:off x="2429065" y="1251823"/>
          <a:ext cx="2051535" cy="15736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9" name="文本框 28">
            <a:extLst>
              <a:ext uri="{FF2B5EF4-FFF2-40B4-BE49-F238E27FC236}">
                <a16:creationId xmlns:a16="http://schemas.microsoft.com/office/drawing/2014/main" id="{C188435C-4B60-40E7-A54E-232D3B9C17A1}"/>
              </a:ext>
            </a:extLst>
          </p:cNvPr>
          <p:cNvSpPr txBox="1"/>
          <p:nvPr/>
        </p:nvSpPr>
        <p:spPr>
          <a:xfrm>
            <a:off x="4354635" y="1907244"/>
            <a:ext cx="8323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py02g0697.1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66E858D-7D42-40A1-9312-EC280A794DC5}"/>
              </a:ext>
            </a:extLst>
          </p:cNvPr>
          <p:cNvSpPr txBox="1"/>
          <p:nvPr/>
        </p:nvSpPr>
        <p:spPr>
          <a:xfrm>
            <a:off x="4354635" y="2020821"/>
            <a:ext cx="1071560" cy="2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M0028693.1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97CF8E07-FFA4-4945-BFCE-7443338FD136}"/>
              </a:ext>
            </a:extLst>
          </p:cNvPr>
          <p:cNvSpPr txBox="1"/>
          <p:nvPr/>
        </p:nvSpPr>
        <p:spPr>
          <a:xfrm>
            <a:off x="4354635" y="2227075"/>
            <a:ext cx="11744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pp.Chr02.00612.1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82866751-89CF-4B84-A597-860E1859168B}"/>
              </a:ext>
            </a:extLst>
          </p:cNvPr>
          <p:cNvSpPr txBox="1"/>
          <p:nvPr/>
        </p:nvSpPr>
        <p:spPr>
          <a:xfrm>
            <a:off x="4354635" y="1536025"/>
            <a:ext cx="1448106" cy="2233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njou_Chr2v0.1_03298.1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EF3E551C-4E58-4E9D-B1B0-CCCCFA730866}"/>
              </a:ext>
            </a:extLst>
          </p:cNvPr>
          <p:cNvSpPr txBox="1"/>
          <p:nvPr/>
        </p:nvSpPr>
        <p:spPr>
          <a:xfrm>
            <a:off x="4354635" y="1711151"/>
            <a:ext cx="1023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ycom02g07050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6D0A51FD-8175-487A-9C0F-6B48879F78D0}"/>
              </a:ext>
            </a:extLst>
          </p:cNvPr>
          <p:cNvSpPr txBox="1"/>
          <p:nvPr/>
        </p:nvSpPr>
        <p:spPr>
          <a:xfrm>
            <a:off x="4354635" y="1357130"/>
            <a:ext cx="114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WHGAAYT031781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5B042A22-D395-49FF-93DF-F681A174D858}"/>
              </a:ext>
            </a:extLst>
          </p:cNvPr>
          <p:cNvSpPr txBox="1"/>
          <p:nvPr/>
        </p:nvSpPr>
        <p:spPr>
          <a:xfrm>
            <a:off x="4354635" y="1197897"/>
            <a:ext cx="8323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dentity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14C2465A-566A-4D36-84D6-248C82BC2772}"/>
              </a:ext>
            </a:extLst>
          </p:cNvPr>
          <p:cNvSpPr txBox="1"/>
          <p:nvPr/>
        </p:nvSpPr>
        <p:spPr>
          <a:xfrm>
            <a:off x="1950638" y="1028543"/>
            <a:ext cx="1668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941877D2-4C31-4080-9C3A-120DE7557B8B}"/>
              </a:ext>
            </a:extLst>
          </p:cNvPr>
          <p:cNvSpPr txBox="1"/>
          <p:nvPr/>
        </p:nvSpPr>
        <p:spPr>
          <a:xfrm>
            <a:off x="4348125" y="994875"/>
            <a:ext cx="1668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B0E5103E-C4C3-440D-8E74-4024592AF492}"/>
              </a:ext>
            </a:extLst>
          </p:cNvPr>
          <p:cNvSpPr txBox="1"/>
          <p:nvPr/>
        </p:nvSpPr>
        <p:spPr>
          <a:xfrm>
            <a:off x="4354635" y="3276166"/>
            <a:ext cx="10715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py02g0699.1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962ED4C1-FE0F-492D-9FFC-8BF41EDA800D}"/>
              </a:ext>
            </a:extLst>
          </p:cNvPr>
          <p:cNvSpPr txBox="1"/>
          <p:nvPr/>
        </p:nvSpPr>
        <p:spPr>
          <a:xfrm>
            <a:off x="4354635" y="3449804"/>
            <a:ext cx="10715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M0035509.1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9FAA3039-A5E7-4944-8BB4-938D05A52266}"/>
              </a:ext>
            </a:extLst>
          </p:cNvPr>
          <p:cNvSpPr txBox="1"/>
          <p:nvPr/>
        </p:nvSpPr>
        <p:spPr>
          <a:xfrm>
            <a:off x="4354635" y="3597555"/>
            <a:ext cx="10715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pp.Chr02.00613.1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344E30CE-4773-4401-BD4C-07406E6E6C11}"/>
              </a:ext>
            </a:extLst>
          </p:cNvPr>
          <p:cNvSpPr txBox="1"/>
          <p:nvPr/>
        </p:nvSpPr>
        <p:spPr>
          <a:xfrm>
            <a:off x="4354635" y="3745306"/>
            <a:ext cx="1448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njou_Chr2v0.1_03299.1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D713B173-E7C8-4965-BAF2-37D25B5C5CBC}"/>
              </a:ext>
            </a:extLst>
          </p:cNvPr>
          <p:cNvSpPr txBox="1"/>
          <p:nvPr/>
        </p:nvSpPr>
        <p:spPr>
          <a:xfrm>
            <a:off x="4354635" y="3891782"/>
            <a:ext cx="13181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ycom02g07060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CEB7D449-A54C-4123-893D-EB7766F3CD8D}"/>
              </a:ext>
            </a:extLst>
          </p:cNvPr>
          <p:cNvSpPr txBox="1"/>
          <p:nvPr/>
        </p:nvSpPr>
        <p:spPr>
          <a:xfrm>
            <a:off x="4354635" y="3110124"/>
            <a:ext cx="11744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WHGAAYT031782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26D149E2-46A0-4722-8B44-691DF9844EDE}"/>
              </a:ext>
            </a:extLst>
          </p:cNvPr>
          <p:cNvSpPr txBox="1"/>
          <p:nvPr/>
        </p:nvSpPr>
        <p:spPr>
          <a:xfrm>
            <a:off x="4354635" y="2985817"/>
            <a:ext cx="10715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dentity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A90FA3EB-DBCE-40E0-A579-E77B618AE0D6}"/>
              </a:ext>
            </a:extLst>
          </p:cNvPr>
          <p:cNvSpPr txBox="1"/>
          <p:nvPr/>
        </p:nvSpPr>
        <p:spPr>
          <a:xfrm>
            <a:off x="4323217" y="2693640"/>
            <a:ext cx="1668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11" name="图表 110">
            <a:extLst>
              <a:ext uri="{FF2B5EF4-FFF2-40B4-BE49-F238E27FC236}">
                <a16:creationId xmlns:a16="http://schemas.microsoft.com/office/drawing/2014/main" id="{F42AA240-684B-476C-86A1-4EF6C83F2FE3}"/>
              </a:ext>
            </a:extLst>
          </p:cNvPr>
          <p:cNvGraphicFramePr>
            <a:graphicFrameLocks/>
          </p:cNvGraphicFramePr>
          <p:nvPr/>
        </p:nvGraphicFramePr>
        <p:xfrm>
          <a:off x="2469653" y="2930329"/>
          <a:ext cx="1764841" cy="14622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2" name="文本框 111">
            <a:extLst>
              <a:ext uri="{FF2B5EF4-FFF2-40B4-BE49-F238E27FC236}">
                <a16:creationId xmlns:a16="http://schemas.microsoft.com/office/drawing/2014/main" id="{2035C4D3-3B02-4277-84B4-E95242677F33}"/>
              </a:ext>
            </a:extLst>
          </p:cNvPr>
          <p:cNvSpPr txBox="1"/>
          <p:nvPr/>
        </p:nvSpPr>
        <p:spPr>
          <a:xfrm rot="16200000">
            <a:off x="2024290" y="3487393"/>
            <a:ext cx="538057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PKM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DC0C46AD-4255-44EC-8CD5-AF92214B7BBB}"/>
              </a:ext>
            </a:extLst>
          </p:cNvPr>
          <p:cNvSpPr txBox="1"/>
          <p:nvPr/>
        </p:nvSpPr>
        <p:spPr>
          <a:xfrm rot="16200000">
            <a:off x="2002040" y="1560213"/>
            <a:ext cx="538057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PKM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D15C2593-113A-4BA7-BB84-3D162CAC275F}"/>
              </a:ext>
            </a:extLst>
          </p:cNvPr>
          <p:cNvSpPr txBox="1"/>
          <p:nvPr/>
        </p:nvSpPr>
        <p:spPr>
          <a:xfrm>
            <a:off x="1950639" y="2791830"/>
            <a:ext cx="1490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33B85732-9BEA-4427-B83D-1415B416F3BF}"/>
              </a:ext>
            </a:extLst>
          </p:cNvPr>
          <p:cNvSpPr txBox="1"/>
          <p:nvPr/>
        </p:nvSpPr>
        <p:spPr>
          <a:xfrm>
            <a:off x="2733979" y="1228806"/>
            <a:ext cx="1054322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pp.Chr02.00612.1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F43E624F-DCA2-464E-A4E4-E9BDEE5D6B42}"/>
              </a:ext>
            </a:extLst>
          </p:cNvPr>
          <p:cNvSpPr txBox="1"/>
          <p:nvPr/>
        </p:nvSpPr>
        <p:spPr>
          <a:xfrm>
            <a:off x="2722813" y="3098080"/>
            <a:ext cx="1054322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pp.Chr02.00613.1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形 4">
            <a:extLst>
              <a:ext uri="{FF2B5EF4-FFF2-40B4-BE49-F238E27FC236}">
                <a16:creationId xmlns:a16="http://schemas.microsoft.com/office/drawing/2014/main" id="{82DBFF49-FB84-4D83-B9BB-06A50750225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rcRect l="19800"/>
          <a:stretch/>
        </p:blipFill>
        <p:spPr>
          <a:xfrm>
            <a:off x="5664521" y="3032973"/>
            <a:ext cx="4277917" cy="1124284"/>
          </a:xfrm>
          <a:prstGeom prst="rect">
            <a:avLst/>
          </a:prstGeom>
        </p:spPr>
      </p:pic>
      <p:pic>
        <p:nvPicPr>
          <p:cNvPr id="7" name="图形 6">
            <a:extLst>
              <a:ext uri="{FF2B5EF4-FFF2-40B4-BE49-F238E27FC236}">
                <a16:creationId xmlns:a16="http://schemas.microsoft.com/office/drawing/2014/main" id="{772AF3F3-4A7B-4789-AD67-C23C8140705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rcRect l="14234"/>
          <a:stretch/>
        </p:blipFill>
        <p:spPr>
          <a:xfrm>
            <a:off x="5655940" y="1224327"/>
            <a:ext cx="4277917" cy="12783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91870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34</Words>
  <Application>Microsoft Office PowerPoint</Application>
  <PresentationFormat>宽屏</PresentationFormat>
  <Paragraphs>2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亚荣</dc:creator>
  <cp:lastModifiedBy>王 亚荣</cp:lastModifiedBy>
  <cp:revision>15</cp:revision>
  <dcterms:created xsi:type="dcterms:W3CDTF">2025-04-18T01:16:52Z</dcterms:created>
  <dcterms:modified xsi:type="dcterms:W3CDTF">2025-04-18T01:29:01Z</dcterms:modified>
</cp:coreProperties>
</file>